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6858000" cy="9144000" type="letter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7" autoAdjust="0"/>
    <p:restoredTop sz="94660"/>
  </p:normalViewPr>
  <p:slideViewPr>
    <p:cSldViewPr snapToGrid="0">
      <p:cViewPr varScale="1">
        <p:scale>
          <a:sx n="73" d="100"/>
          <a:sy n="73" d="100"/>
        </p:scale>
        <p:origin x="189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749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6862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8184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716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562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044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6752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702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493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479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5473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C64AE-17B8-4E39-A12E-13296571967E}" type="datetimeFigureOut">
              <a:rPr kumimoji="1" lang="ja-JP" altLang="en-US" smtClean="0"/>
              <a:t>2019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C3906-AB5A-4C74-95FF-3A693DF50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547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336C53-3A4B-4E72-90D6-74086B959961}"/>
              </a:ext>
            </a:extLst>
          </p:cNvPr>
          <p:cNvSpPr txBox="1"/>
          <p:nvPr/>
        </p:nvSpPr>
        <p:spPr>
          <a:xfrm>
            <a:off x="270882" y="676043"/>
            <a:ext cx="6336991" cy="82176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 1 115921403 </a:t>
            </a:r>
            <a:r>
              <a:rPr kumimoji="1" lang="en-US" altLang="ja-JP" sz="8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snp</a:t>
            </a:r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A C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ATTTAATACTATATTTGCTTAAAATATACATGTCTGTCTCCCTCTCTCTCTCTCTATATATATATATGTATATTACATAATCCACATGCTTATCACAC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|||||||||||||||| |||||||||||||||||||||||||||||||||||||||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ATTTAATACTATATTTGCTTAAAATATACATGTCTGTCTCCCTCTCTCTCTCTCTCTATATATATATGTATATTACATAATCCACATGCTTATCACAC</a:t>
            </a:r>
          </a:p>
          <a:p>
            <a:endParaRPr kumimoji="1" lang="ja-JP" alt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 1 45545715 1 45545704 f insertion 2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GCCTCCTCTGTCGCCACAC TTAGCCCCTCTGGACTGTGA 5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Chr1 45545715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TTTCAGCCTCCTCTGTCGCCACACAAGGCCAACCCTGCACACACACATAGGTATGCATTCTGCCTGTTCTACATTAGCCCCTCTGGACTGTGAACCTTG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|||||| |    |      |     |  |  |      || ||      ||        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GTTTCAGCCTCCTCTGTCGCCACACAAGGCCAACCCTGCACACACACACATAGGTATGCATTCTGCCTGTTCTACATTAGCCCCTCTGGACTGTGAACCTT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| |      |  || |  |  ||||         |    ||||||||||||||||||||||||||||||||||||||||||||||||||||||||||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TGTTTCAGCCTCCTCTGTCGCCACACAAGGCCAACCCTGCACACACACATAGGTATGCATTCTGCCTGTTCTACATTAGCCCCTCTGGACTGTGAACCTT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Chr1 45545704</a:t>
            </a:r>
          </a:p>
          <a:p>
            <a:endParaRPr kumimoji="1" lang="en-US" altLang="ja-JP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 1 60407376 1 60407371 f deletion -1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TTGTCCAAAATCCTAGAGA AGAAACCCTCTTTTTCTGCC 5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Chr1 60407376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TGATTGTCCAAAATCCTAGAGACATCCAACATACAAAAAATAGGAAGAAACTGTTCCTTCTCCCCAACATGACTAGAAACCCTCTTTTTCTGCCT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   | |  ||    | | |   ||| |          || ||   ||||    |  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TGATTGTCCAAAATCCTAGAGACATCCAACATACAAAAATAGGAAGAAACTGTTCCTTCTCCCCAACATGACTAGAAACCCTCTTTTTCTGCCTA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     |   | |||  |          | |      |||||||||||||||||||||||||||||||||||||||||||||||||||||||||||||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GTGATTGTCCAAAATCCTAGAGACATCCAACATACAAAAAATAGGAAGAAACTGTTCCTTCTCCCCAACATGACTAGAAACCCTCTTTTTCTGCCTA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Chr1 60407371</a:t>
            </a:r>
          </a:p>
          <a:p>
            <a:endParaRPr kumimoji="1" lang="ja-JP" alt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 1 72300642 1 72346156 f deletion -45516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GGTACAAGACAAAAATA TAATCTCTTGAACCACTTTC 5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Chr1 72300642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TGAAAAGGGTACAAGACAAAAATAAAAGTTAAAGAAAAACCAAATGCAATAGTAGAATTAAAATTCATATTCTAAATATTAAAACATAAAAACATACAAG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|||||    ||      |   | |    ||      ||      |   |       || 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TGAAAAGGGTACAAGACAAAAATAAAAGTTAAAGAAAAACCAAATGACTGAGAGATTATCTCAGTGGATTTGACTTAATCTCTTGAACCACTTTCTA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   |    ||  |    ||  |           |  | |    | ||||||||||||||||||||||||||||||||||||||||||||||||||||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GAGATTTTGTTGATTTAAATGAAGTCCCAGCTTGGTAGATTTTAAGACTGAGAGATTATCTCAGTGGATTTGACTTAATCTCTTGAACCACTTTCTA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Chr1 72346156</a:t>
            </a:r>
          </a:p>
          <a:p>
            <a:endParaRPr kumimoji="1" lang="ja-JP" alt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 1 197787659 1 197788857 r inversion 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CAATGCCCCTAGAAACCCCT ATCACTCTAGAATCTAAATA 5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Chr1 197787659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GCTACAATGCCCCTAGAAACCCCTCACAGCAAAGGCCCTCAAATTGGAGACTGGTTAGGAGCCTAGGACTGTGGATAGTGGCCTCATGCCTGAAGCCATG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|||  |        ||          |   |  |      |   |  |   |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GCTACAATGCCCCTAGAAACCCCTCACAGCAAAGGCCCTCAAATGAGTTTACATCTATTGTGTCCCCAAACTTTAATCACTCTAGAATCTAAATATATAG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        |||    |      |        |           ||||||||||||||||||||||||||||||||||||||||||||||||||||||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GGGGCTGGCCTGCTGCTGGGGCAGGTGTTGAGCCTGGGTTTGTGAGTTTACATCTATTGTGTCCCCAAACTTTAATCACTCTAGAATCTAAATATATAG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Chr1 197788857</a:t>
            </a:r>
          </a:p>
          <a:p>
            <a:endParaRPr kumimoji="1" lang="en-US" altLang="ja-JP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# 1 109304170 7 24551505 f translocation 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CCATCTGACATATTAGATA TAAGATTCTCACCATTAAAA 5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Chr1 109304170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CTCACCATCTGACATATTAGATACTTTACTTGTTTATTTATTGTCTAGCTCCCTCCACTAGAATCTAACTTCCATGAGGGCAGTTATTTTTACCTATTT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||||||||||||||||||||||||||||||||||||||||||||||||||||||||||| || |     |      | ||          || |   |   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TTCTCACCATCTGACATATTAGATACTTTACTTGTTTATTTATTGTCTAGCTCCCTCCAGTACACCTAGAAACAGTTAAGATTCTCACCATTAAAAAA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|||      |             |||  || ||      |   |    | |||||||||||||||||||||||||||||||||||||||||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AAGAAGAATTCTAGAGATTGGTTGTGCAGCAATGTGAATGTACCTAACACTACTGAACTGTACACCTAGAAACAGTTAAGATTCTCACCATTAAAAAAAAA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|</a:t>
            </a:r>
          </a:p>
          <a:p>
            <a:r>
              <a:rPr kumimoji="1" lang="en-US" altLang="ja-JP" sz="8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Chr7 24551505</a:t>
            </a:r>
            <a:endParaRPr kumimoji="1" lang="ja-JP" altLang="en-US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10F6108-F0A3-4556-B295-7D27EB921A23}"/>
              </a:ext>
            </a:extLst>
          </p:cNvPr>
          <p:cNvSpPr txBox="1"/>
          <p:nvPr/>
        </p:nvSpPr>
        <p:spPr>
          <a:xfrm>
            <a:off x="95250" y="174123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ry figure 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22582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24</TotalTime>
  <Words>232</Words>
  <Application>Microsoft Office PowerPoint</Application>
  <PresentationFormat>レター サイズ 8.5x11 インチ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Courier New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尾安藝雄</dc:creator>
  <cp:lastModifiedBy>宮尾 安藝雄</cp:lastModifiedBy>
  <cp:revision>123</cp:revision>
  <cp:lastPrinted>2017-09-12T07:22:56Z</cp:lastPrinted>
  <dcterms:created xsi:type="dcterms:W3CDTF">2016-09-29T15:12:10Z</dcterms:created>
  <dcterms:modified xsi:type="dcterms:W3CDTF">2019-04-02T07:09:39Z</dcterms:modified>
</cp:coreProperties>
</file>